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125" d="100"/>
          <a:sy n="125" d="100"/>
        </p:scale>
        <p:origin x="1242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8AFC6AD-8741-BFB0-4E6C-C8442B55814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0A909449-B6B5-6C67-C3F5-46F590E2BEE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9DC05CB-185D-1BD8-576B-FE307BD575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84000-7931-4CF9-92F1-375531710214}" type="datetimeFigureOut">
              <a:rPr kumimoji="1" lang="ja-JP" altLang="en-US" smtClean="0"/>
              <a:t>2023/10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DEE130F-7357-086A-38EB-6C2288E47A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2DF2558-736F-9986-4AB5-6B039BD178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BE566A-7D0D-4CA5-9E74-0C9D2A88FB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64144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FEDC92B-85E1-8EF3-EA25-A2C23FE935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7C7BE055-50CF-8C33-C171-4AF78B92D69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A6FD0AF-F126-83AE-844F-02E2503C90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84000-7931-4CF9-92F1-375531710214}" type="datetimeFigureOut">
              <a:rPr kumimoji="1" lang="ja-JP" altLang="en-US" smtClean="0"/>
              <a:t>2023/10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6BC0FD7-4945-DF97-FC66-3B2F4ECF70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748F4E5-029F-568F-1E87-28A4DAC2B0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BE566A-7D0D-4CA5-9E74-0C9D2A88FB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0413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DBD49BBF-59BB-1FF4-F006-1BFE48529A3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E9EB98C2-D42B-78F6-461D-A8A0AE166B2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78ED146-C494-DA39-8BAC-A63F789093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84000-7931-4CF9-92F1-375531710214}" type="datetimeFigureOut">
              <a:rPr kumimoji="1" lang="ja-JP" altLang="en-US" smtClean="0"/>
              <a:t>2023/10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CE5F76D-09F7-C3D2-040E-2FB2AA6C46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F4540E9-650F-B9E4-5855-ADDE1B9C1D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BE566A-7D0D-4CA5-9E74-0C9D2A88FB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01102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E920007-5B8A-75AC-1B38-6070B2A512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CEAE029-EB55-BAB3-AE26-83E445B9C12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B2B5F9A-BE7E-7B86-D275-48F7440D52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84000-7931-4CF9-92F1-375531710214}" type="datetimeFigureOut">
              <a:rPr kumimoji="1" lang="ja-JP" altLang="en-US" smtClean="0"/>
              <a:t>2023/10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9662232-B50E-CD27-B6B2-572C275EF6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E476F56-0657-E667-3EDB-4D811A8546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BE566A-7D0D-4CA5-9E74-0C9D2A88FB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08388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8718319-5EBC-00C1-407F-57AB466BFA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55F28A7-3DF6-EE1A-5C11-F367B72FE1F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7F268BB-C49B-7631-D1FA-2B2191AE0B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84000-7931-4CF9-92F1-375531710214}" type="datetimeFigureOut">
              <a:rPr kumimoji="1" lang="ja-JP" altLang="en-US" smtClean="0"/>
              <a:t>2023/10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AC3C7CB-B09C-37F8-3AFA-ACCEBC5F51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E435F3D-3536-2022-6051-6AE6D50D1A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BE566A-7D0D-4CA5-9E74-0C9D2A88FB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55776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3BDA894-065B-A6D7-5BE4-63C05CC8F6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45252B3-B8B2-036C-3935-EFD39676EE7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51A9FD85-B5C0-0EA1-838E-1A79CA92AC6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017C7DB-68CE-E68C-EFDF-9408BCB3B4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84000-7931-4CF9-92F1-375531710214}" type="datetimeFigureOut">
              <a:rPr kumimoji="1" lang="ja-JP" altLang="en-US" smtClean="0"/>
              <a:t>2023/10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5D2E771-DD45-494D-9939-94618D35C9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95F2ECB-7B52-ECC1-2541-6FC6B82C97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BE566A-7D0D-4CA5-9E74-0C9D2A88FB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33626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1ED5ED9-23F3-07C9-8394-D8B5BD4613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2990A87-4B17-FC19-501B-10186E6B048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8B98688F-ACED-0542-895B-8A94C46A51E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1C4A6331-E43F-2E7D-A6FC-60E7BB6D3A7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E2757430-6968-5CDD-26BC-48F8FA24C5F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32E94726-ABF6-88BB-6AA2-A546063653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84000-7931-4CF9-92F1-375531710214}" type="datetimeFigureOut">
              <a:rPr kumimoji="1" lang="ja-JP" altLang="en-US" smtClean="0"/>
              <a:t>2023/10/13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BED671A2-CC29-1038-F07B-CAF6DFEBEE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AF11AFBF-7064-331A-0D95-DA896FA23A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BE566A-7D0D-4CA5-9E74-0C9D2A88FB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93946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9D56ACB-C696-AC57-3197-4906B5B171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EB743034-01E2-13C6-F70C-21F4404D58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84000-7931-4CF9-92F1-375531710214}" type="datetimeFigureOut">
              <a:rPr kumimoji="1" lang="ja-JP" altLang="en-US" smtClean="0"/>
              <a:t>2023/10/13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F221A68D-13B8-5094-74A1-C9D33AD05C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E1254632-3475-62B5-9069-2B8D150100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BE566A-7D0D-4CA5-9E74-0C9D2A88FB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054785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270A89B2-FB89-FC35-D393-E318C6875E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84000-7931-4CF9-92F1-375531710214}" type="datetimeFigureOut">
              <a:rPr kumimoji="1" lang="ja-JP" altLang="en-US" smtClean="0"/>
              <a:t>2023/10/13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D0D3912B-E60B-8B78-E245-6B000A76D1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6CCE1078-AEF7-7DED-8801-777D2799D3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BE566A-7D0D-4CA5-9E74-0C9D2A88FB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86216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E678D44-DB49-E883-FDFA-64B0060C85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D091A4B-F175-4C5F-0AEB-B108817D3A8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5E3FA243-FDDE-946E-45C7-B11BE174561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01D67B3-7529-4677-04FE-8E7A166399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84000-7931-4CF9-92F1-375531710214}" type="datetimeFigureOut">
              <a:rPr kumimoji="1" lang="ja-JP" altLang="en-US" smtClean="0"/>
              <a:t>2023/10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F0F6131-2539-A5C7-AFD0-DB6314AF7D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277408D-4857-00DA-D341-8DF11B4749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BE566A-7D0D-4CA5-9E74-0C9D2A88FB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21102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206242B-6DB4-D7B1-42AC-C6633BF34B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22D78959-1135-3E49-ECD2-10B8E2B9F61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F743262A-36E5-DED0-CA49-55C8CBEC421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992D9EA-16E5-6848-B20C-E43B4ABB12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84000-7931-4CF9-92F1-375531710214}" type="datetimeFigureOut">
              <a:rPr kumimoji="1" lang="ja-JP" altLang="en-US" smtClean="0"/>
              <a:t>2023/10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4CB7E69-EA49-C389-D2BA-CAC7EADD29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AC776C7-B777-7EFF-D34B-432BAC4AAC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BE566A-7D0D-4CA5-9E74-0C9D2A88FB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27652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23149057-77DC-592C-1432-4C17137324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A970A55-02B0-232A-5E08-24793C2BBA4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55EF5AC-EB4D-34A8-79CA-6CD59C1D74C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884000-7931-4CF9-92F1-375531710214}" type="datetimeFigureOut">
              <a:rPr kumimoji="1" lang="ja-JP" altLang="en-US" smtClean="0"/>
              <a:t>2023/10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61DFB56-0328-828A-A036-0C129B7B987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C01E78A-D9BD-D309-7607-71FDF0E6BA6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BE566A-7D0D-4CA5-9E74-0C9D2A88FB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835448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kumimoji="1"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8" indent="-128588" algn="l" defTabSz="51435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kumimoji="1"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1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3" Type="http://schemas.openxmlformats.org/officeDocument/2006/relationships/image" Target="../media/image2.png"/><Relationship Id="rId21" Type="http://schemas.openxmlformats.org/officeDocument/2006/relationships/image" Target="../media/image20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4">
            <a:extLst>
              <a:ext uri="{FF2B5EF4-FFF2-40B4-BE49-F238E27FC236}">
                <a16:creationId xmlns:a16="http://schemas.microsoft.com/office/drawing/2014/main" id="{487A924C-0B95-BD40-3F4F-32B90472A82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11854885"/>
              </p:ext>
            </p:extLst>
          </p:nvPr>
        </p:nvGraphicFramePr>
        <p:xfrm>
          <a:off x="7015" y="227606"/>
          <a:ext cx="6838918" cy="9266587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03568">
                  <a:extLst>
                    <a:ext uri="{9D8B030D-6E8A-4147-A177-3AD203B41FA5}">
                      <a16:colId xmlns:a16="http://schemas.microsoft.com/office/drawing/2014/main" val="2986735052"/>
                    </a:ext>
                  </a:extLst>
                </a:gridCol>
                <a:gridCol w="2658397">
                  <a:extLst>
                    <a:ext uri="{9D8B030D-6E8A-4147-A177-3AD203B41FA5}">
                      <a16:colId xmlns:a16="http://schemas.microsoft.com/office/drawing/2014/main" val="1634945780"/>
                    </a:ext>
                  </a:extLst>
                </a:gridCol>
                <a:gridCol w="574992">
                  <a:extLst>
                    <a:ext uri="{9D8B030D-6E8A-4147-A177-3AD203B41FA5}">
                      <a16:colId xmlns:a16="http://schemas.microsoft.com/office/drawing/2014/main" val="3633805689"/>
                    </a:ext>
                  </a:extLst>
                </a:gridCol>
                <a:gridCol w="443230">
                  <a:extLst>
                    <a:ext uri="{9D8B030D-6E8A-4147-A177-3AD203B41FA5}">
                      <a16:colId xmlns:a16="http://schemas.microsoft.com/office/drawing/2014/main" val="2240180366"/>
                    </a:ext>
                  </a:extLst>
                </a:gridCol>
                <a:gridCol w="403542">
                  <a:extLst>
                    <a:ext uri="{9D8B030D-6E8A-4147-A177-3AD203B41FA5}">
                      <a16:colId xmlns:a16="http://schemas.microsoft.com/office/drawing/2014/main" val="2573610804"/>
                    </a:ext>
                  </a:extLst>
                </a:gridCol>
                <a:gridCol w="1005205">
                  <a:extLst>
                    <a:ext uri="{9D8B030D-6E8A-4147-A177-3AD203B41FA5}">
                      <a16:colId xmlns:a16="http://schemas.microsoft.com/office/drawing/2014/main" val="3099658021"/>
                    </a:ext>
                  </a:extLst>
                </a:gridCol>
                <a:gridCol w="600392">
                  <a:extLst>
                    <a:ext uri="{9D8B030D-6E8A-4147-A177-3AD203B41FA5}">
                      <a16:colId xmlns:a16="http://schemas.microsoft.com/office/drawing/2014/main" val="2697512666"/>
                    </a:ext>
                  </a:extLst>
                </a:gridCol>
                <a:gridCol w="549592">
                  <a:extLst>
                    <a:ext uri="{9D8B030D-6E8A-4147-A177-3AD203B41FA5}">
                      <a16:colId xmlns:a16="http://schemas.microsoft.com/office/drawing/2014/main" val="3207419821"/>
                    </a:ext>
                  </a:extLst>
                </a:gridCol>
              </a:tblGrid>
              <a:tr h="474387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tif ID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tif logo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-value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rt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d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uery ID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main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nown</a:t>
                      </a:r>
                    </a:p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tif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321117705"/>
                  </a:ext>
                </a:extLst>
              </a:tr>
              <a:tr h="43961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tif_1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3.0e-780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9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P_004248175.2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DA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464942947"/>
                  </a:ext>
                </a:extLst>
              </a:tr>
              <a:tr h="439610"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otif_2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6e-1488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1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90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XP_004248175.2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32613998"/>
                  </a:ext>
                </a:extLst>
              </a:tr>
              <a:tr h="439610"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otif_3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6.6e-719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04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32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XP_004248175.2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157644341"/>
                  </a:ext>
                </a:extLst>
              </a:tr>
              <a:tr h="439610"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otif_4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6.3e-484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46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66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XP_004248175.2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B-ARC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331303706"/>
                  </a:ext>
                </a:extLst>
              </a:tr>
              <a:tr h="439610"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otif_5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3.9e-1190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71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08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XP_004248175.2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NB-ARC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loop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894192227"/>
                  </a:ext>
                </a:extLst>
              </a:tr>
              <a:tr h="439610"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otif_6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6e-693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10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38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XP_004248175.2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NB-ARC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178933675"/>
                  </a:ext>
                </a:extLst>
              </a:tr>
              <a:tr h="439610"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otif_7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9.8e-422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39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59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XP_004248175.2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NB-ARC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589440869"/>
                  </a:ext>
                </a:extLst>
              </a:tr>
              <a:tr h="439610"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otif_8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4e-1542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60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309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XP_004248175.2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NB-ARC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16150871"/>
                  </a:ext>
                </a:extLst>
              </a:tr>
              <a:tr h="439610"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otif_9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8e-648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310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338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XP_004248175.2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NB-ARC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585508223"/>
                  </a:ext>
                </a:extLst>
              </a:tr>
              <a:tr h="439610"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otif_10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2e-1373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339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388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XP_004248175.2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NB-ARC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446247368"/>
                  </a:ext>
                </a:extLst>
              </a:tr>
              <a:tr h="439610"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otif_11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9.1e-1740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389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38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XP_004248175.2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NB-ARC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344338370"/>
                  </a:ext>
                </a:extLst>
              </a:tr>
              <a:tr h="439610"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otif_12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9.4e-1268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47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89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XP_004248175.2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NB-ARC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HD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354897339"/>
                  </a:ext>
                </a:extLst>
              </a:tr>
              <a:tr h="439610"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otif_13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.8e-1311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511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560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XP_004248175.2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RR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04270617"/>
                  </a:ext>
                </a:extLst>
              </a:tr>
              <a:tr h="439610"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otif_14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9e-423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565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585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XP_004248175.2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LRR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110379830"/>
                  </a:ext>
                </a:extLst>
              </a:tr>
              <a:tr h="439610"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otif_15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3e-991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586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623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XP_004248175.2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LRR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593235494"/>
                  </a:ext>
                </a:extLst>
              </a:tr>
              <a:tr h="439610"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otif_16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5.3e-1042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640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675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XP_004248175.2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LRR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807897173"/>
                  </a:ext>
                </a:extLst>
              </a:tr>
              <a:tr h="439610"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otif_17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.0e-536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676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696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XP_004248175.2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LRR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213606417"/>
                  </a:ext>
                </a:extLst>
              </a:tr>
              <a:tr h="439610"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otif_18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5.1e-767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00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31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XP_004248175.2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LRR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01621772"/>
                  </a:ext>
                </a:extLst>
              </a:tr>
              <a:tr h="439610"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otif_19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6.2e-1591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40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89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XP_004248175.2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LRR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132431135"/>
                  </a:ext>
                </a:extLst>
              </a:tr>
              <a:tr h="439610"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otif_20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.9e-1264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810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859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XP_004248175.2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LRR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945761831"/>
                  </a:ext>
                </a:extLst>
              </a:tr>
            </a:tbl>
          </a:graphicData>
        </a:graphic>
      </p:graphicFrame>
      <p:pic>
        <p:nvPicPr>
          <p:cNvPr id="6" name="図 5" descr="モニター画面に映る文字&#10;&#10;中程度の精度で自動的に生成された説明">
            <a:extLst>
              <a:ext uri="{FF2B5EF4-FFF2-40B4-BE49-F238E27FC236}">
                <a16:creationId xmlns:a16="http://schemas.microsoft.com/office/drawing/2014/main" id="{058C5E5A-9428-E663-A8BD-4C66F08ED70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29973" y="744925"/>
            <a:ext cx="1554472" cy="360000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010FCEC7-C89E-0F27-B9C9-FF8E36827C8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9972" y="1184252"/>
            <a:ext cx="2621965" cy="360000"/>
          </a:xfrm>
          <a:prstGeom prst="rect">
            <a:avLst/>
          </a:prstGeom>
        </p:spPr>
      </p:pic>
      <p:pic>
        <p:nvPicPr>
          <p:cNvPr id="1026" name="Picture 2">
            <a:extLst>
              <a:ext uri="{FF2B5EF4-FFF2-40B4-BE49-F238E27FC236}">
                <a16:creationId xmlns:a16="http://schemas.microsoft.com/office/drawing/2014/main" id="{2A614CA8-C500-298E-AE26-79A384C479E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9972" y="1623579"/>
            <a:ext cx="1553201" cy="3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A0EE2C60-FE1A-292B-4122-A48D3BBA851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29972" y="2062906"/>
            <a:ext cx="1148117" cy="360000"/>
          </a:xfrm>
          <a:prstGeom prst="rect">
            <a:avLst/>
          </a:prstGeom>
        </p:spPr>
      </p:pic>
      <p:pic>
        <p:nvPicPr>
          <p:cNvPr id="1028" name="Picture 4">
            <a:extLst>
              <a:ext uri="{FF2B5EF4-FFF2-40B4-BE49-F238E27FC236}">
                <a16:creationId xmlns:a16="http://schemas.microsoft.com/office/drawing/2014/main" id="{E551106A-C9F8-E582-431B-AC75062B95E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9972" y="2502233"/>
            <a:ext cx="2010420" cy="3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85B70BF6-CD06-9770-3D38-8E1DC98DB81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29972" y="2941560"/>
            <a:ext cx="1554473" cy="360000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D685EED0-1316-6945-0F09-6758C3396A3D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29972" y="3380887"/>
            <a:ext cx="1148117" cy="360000"/>
          </a:xfrm>
          <a:prstGeom prst="rect">
            <a:avLst/>
          </a:prstGeom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46E2E2DD-6949-65A6-0ABF-D5888E99EA91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29972" y="3820214"/>
            <a:ext cx="2621963" cy="360000"/>
          </a:xfrm>
          <a:prstGeom prst="rect">
            <a:avLst/>
          </a:prstGeom>
        </p:spPr>
      </p:pic>
      <p:pic>
        <p:nvPicPr>
          <p:cNvPr id="12" name="図 11">
            <a:extLst>
              <a:ext uri="{FF2B5EF4-FFF2-40B4-BE49-F238E27FC236}">
                <a16:creationId xmlns:a16="http://schemas.microsoft.com/office/drawing/2014/main" id="{E68368D7-C8ED-F883-C882-B5CA87F8B055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629972" y="4259541"/>
            <a:ext cx="1554473" cy="360000"/>
          </a:xfrm>
          <a:prstGeom prst="rect">
            <a:avLst/>
          </a:prstGeom>
        </p:spPr>
      </p:pic>
      <p:pic>
        <p:nvPicPr>
          <p:cNvPr id="13" name="図 12">
            <a:extLst>
              <a:ext uri="{FF2B5EF4-FFF2-40B4-BE49-F238E27FC236}">
                <a16:creationId xmlns:a16="http://schemas.microsoft.com/office/drawing/2014/main" id="{712EEF0F-94DB-F4EB-AD23-CF3D19CE676E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629972" y="4698868"/>
            <a:ext cx="2621963" cy="360000"/>
          </a:xfrm>
          <a:prstGeom prst="rect">
            <a:avLst/>
          </a:prstGeom>
        </p:spPr>
      </p:pic>
      <p:pic>
        <p:nvPicPr>
          <p:cNvPr id="1030" name="Picture 6">
            <a:extLst>
              <a:ext uri="{FF2B5EF4-FFF2-40B4-BE49-F238E27FC236}">
                <a16:creationId xmlns:a16="http://schemas.microsoft.com/office/drawing/2014/main" id="{84644332-F603-CAB4-EA33-06E74595EF7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9972" y="5138195"/>
            <a:ext cx="2623768" cy="3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2" name="Picture 8">
            <a:extLst>
              <a:ext uri="{FF2B5EF4-FFF2-40B4-BE49-F238E27FC236}">
                <a16:creationId xmlns:a16="http://schemas.microsoft.com/office/drawing/2014/main" id="{E1D8BE24-3ABA-D997-2809-35FE231F864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9973" y="5577522"/>
            <a:ext cx="2265400" cy="3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4" name="Picture 10">
            <a:extLst>
              <a:ext uri="{FF2B5EF4-FFF2-40B4-BE49-F238E27FC236}">
                <a16:creationId xmlns:a16="http://schemas.microsoft.com/office/drawing/2014/main" id="{6ADEC869-D9D3-9603-2064-BD0B276017A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9972" y="6016849"/>
            <a:ext cx="2623768" cy="3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6" name="Picture 12">
            <a:extLst>
              <a:ext uri="{FF2B5EF4-FFF2-40B4-BE49-F238E27FC236}">
                <a16:creationId xmlns:a16="http://schemas.microsoft.com/office/drawing/2014/main" id="{F1888D79-0CFA-4EDA-412A-A9C7CD4AC21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9972" y="6456176"/>
            <a:ext cx="1148102" cy="3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8" name="Picture 14">
            <a:extLst>
              <a:ext uri="{FF2B5EF4-FFF2-40B4-BE49-F238E27FC236}">
                <a16:creationId xmlns:a16="http://schemas.microsoft.com/office/drawing/2014/main" id="{A4960D58-3292-0522-4393-88788D7C213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9972" y="6895503"/>
            <a:ext cx="2010420" cy="3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0" name="Picture 16">
            <a:extLst>
              <a:ext uri="{FF2B5EF4-FFF2-40B4-BE49-F238E27FC236}">
                <a16:creationId xmlns:a16="http://schemas.microsoft.com/office/drawing/2014/main" id="{A1292230-133F-53B1-77EF-5232B52F89C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9972" y="7334830"/>
            <a:ext cx="1911140" cy="3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2" name="Picture 18">
            <a:extLst>
              <a:ext uri="{FF2B5EF4-FFF2-40B4-BE49-F238E27FC236}">
                <a16:creationId xmlns:a16="http://schemas.microsoft.com/office/drawing/2014/main" id="{465D0787-D9F8-DEF8-885B-826410EC491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9972" y="7774157"/>
            <a:ext cx="1148102" cy="3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4" name="Picture 20">
            <a:extLst>
              <a:ext uri="{FF2B5EF4-FFF2-40B4-BE49-F238E27FC236}">
                <a16:creationId xmlns:a16="http://schemas.microsoft.com/office/drawing/2014/main" id="{887965FB-52F1-918F-F796-E737AB57AC3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9972" y="8213484"/>
            <a:ext cx="1707379" cy="3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6" name="Picture 22">
            <a:extLst>
              <a:ext uri="{FF2B5EF4-FFF2-40B4-BE49-F238E27FC236}">
                <a16:creationId xmlns:a16="http://schemas.microsoft.com/office/drawing/2014/main" id="{FB58F1B0-A9D6-0B81-D9DE-2F3561F1F61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9972" y="8652811"/>
            <a:ext cx="2623768" cy="3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8" name="Picture 24">
            <a:extLst>
              <a:ext uri="{FF2B5EF4-FFF2-40B4-BE49-F238E27FC236}">
                <a16:creationId xmlns:a16="http://schemas.microsoft.com/office/drawing/2014/main" id="{3339A060-545C-D1D1-BAA7-441CAACEF8B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9972" y="9092144"/>
            <a:ext cx="2623768" cy="3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182FF191-10F5-0D26-2135-AD64683D8BD6}"/>
              </a:ext>
            </a:extLst>
          </p:cNvPr>
          <p:cNvSpPr/>
          <p:nvPr/>
        </p:nvSpPr>
        <p:spPr>
          <a:xfrm>
            <a:off x="698501" y="744925"/>
            <a:ext cx="1067434" cy="359994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4" name="正方形/長方形 23">
            <a:extLst>
              <a:ext uri="{FF2B5EF4-FFF2-40B4-BE49-F238E27FC236}">
                <a16:creationId xmlns:a16="http://schemas.microsoft.com/office/drawing/2014/main" id="{DC7C56D8-A2EA-2E03-8E8A-8F046140E4C4}"/>
              </a:ext>
            </a:extLst>
          </p:cNvPr>
          <p:cNvSpPr/>
          <p:nvPr/>
        </p:nvSpPr>
        <p:spPr>
          <a:xfrm>
            <a:off x="1356359" y="2505904"/>
            <a:ext cx="464821" cy="359994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5" name="正方形/長方形 24">
            <a:extLst>
              <a:ext uri="{FF2B5EF4-FFF2-40B4-BE49-F238E27FC236}">
                <a16:creationId xmlns:a16="http://schemas.microsoft.com/office/drawing/2014/main" id="{7AEC28CB-C1AD-9FD8-5818-FCD868213904}"/>
              </a:ext>
            </a:extLst>
          </p:cNvPr>
          <p:cNvSpPr/>
          <p:nvPr/>
        </p:nvSpPr>
        <p:spPr>
          <a:xfrm>
            <a:off x="2225083" y="5583237"/>
            <a:ext cx="152357" cy="359994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136DC950-28E8-B808-7AAC-A13C5FEBCEFA}"/>
              </a:ext>
            </a:extLst>
          </p:cNvPr>
          <p:cNvSpPr txBox="1"/>
          <p:nvPr/>
        </p:nvSpPr>
        <p:spPr>
          <a:xfrm>
            <a:off x="-605" y="0"/>
            <a:ext cx="450402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b="1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upplemental Table S4. List of MEME motifs predicted from NRC0.</a:t>
            </a:r>
            <a:endParaRPr lang="ja-JP" altLang="ja-JP" sz="1050" b="1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102547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7</TotalTime>
  <Words>227</Words>
  <Application>Microsoft Office PowerPoint</Application>
  <PresentationFormat>A4 210 x 297 mm</PresentationFormat>
  <Paragraphs>13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oshi</dc:creator>
  <cp:lastModifiedBy>Toshiyuki Sakai</cp:lastModifiedBy>
  <cp:revision>6</cp:revision>
  <dcterms:created xsi:type="dcterms:W3CDTF">2023-08-31T06:35:32Z</dcterms:created>
  <dcterms:modified xsi:type="dcterms:W3CDTF">2023-10-13T14:52:56Z</dcterms:modified>
</cp:coreProperties>
</file>